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7FC96DA-6BD9-9C8C-7246-44C136EB6E17}" name="BODDUPALLI, Prasanna (CIMMYT-Kenya)" initials="PB" userId="S::b.m.prasanna@cimmyt.org::b8b648be-009e-49ac-bcd4-60c1fce1e5e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21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IRNS, Jill Elizabeth (CIMMYT-Zimbabwe)" userId="a5b6228f-5cdd-4f40-b78c-ba4e8c2e086b" providerId="ADAL" clId="{44492767-D7D2-48AC-A1D8-C1FADBF7B2F2}"/>
    <pc:docChg chg="delSld modSld">
      <pc:chgData name="CAIRNS, Jill Elizabeth (CIMMYT-Zimbabwe)" userId="a5b6228f-5cdd-4f40-b78c-ba4e8c2e086b" providerId="ADAL" clId="{44492767-D7D2-48AC-A1D8-C1FADBF7B2F2}" dt="2024-09-15T15:44:34.997" v="6" actId="113"/>
      <pc:docMkLst>
        <pc:docMk/>
      </pc:docMkLst>
      <pc:sldChg chg="del">
        <pc:chgData name="CAIRNS, Jill Elizabeth (CIMMYT-Zimbabwe)" userId="a5b6228f-5cdd-4f40-b78c-ba4e8c2e086b" providerId="ADAL" clId="{44492767-D7D2-48AC-A1D8-C1FADBF7B2F2}" dt="2024-09-15T15:44:26.694" v="0" actId="47"/>
        <pc:sldMkLst>
          <pc:docMk/>
          <pc:sldMk cId="3908547234" sldId="256"/>
        </pc:sldMkLst>
      </pc:sldChg>
      <pc:sldChg chg="del">
        <pc:chgData name="CAIRNS, Jill Elizabeth (CIMMYT-Zimbabwe)" userId="a5b6228f-5cdd-4f40-b78c-ba4e8c2e086b" providerId="ADAL" clId="{44492767-D7D2-48AC-A1D8-C1FADBF7B2F2}" dt="2024-09-15T15:44:26.942" v="1" actId="47"/>
        <pc:sldMkLst>
          <pc:docMk/>
          <pc:sldMk cId="1740101965" sldId="257"/>
        </pc:sldMkLst>
      </pc:sldChg>
      <pc:sldChg chg="del">
        <pc:chgData name="CAIRNS, Jill Elizabeth (CIMMYT-Zimbabwe)" userId="a5b6228f-5cdd-4f40-b78c-ba4e8c2e086b" providerId="ADAL" clId="{44492767-D7D2-48AC-A1D8-C1FADBF7B2F2}" dt="2024-09-15T15:44:27.111" v="2" actId="47"/>
        <pc:sldMkLst>
          <pc:docMk/>
          <pc:sldMk cId="1734801759" sldId="258"/>
        </pc:sldMkLst>
      </pc:sldChg>
      <pc:sldChg chg="del">
        <pc:chgData name="CAIRNS, Jill Elizabeth (CIMMYT-Zimbabwe)" userId="a5b6228f-5cdd-4f40-b78c-ba4e8c2e086b" providerId="ADAL" clId="{44492767-D7D2-48AC-A1D8-C1FADBF7B2F2}" dt="2024-09-15T15:44:27.626" v="3" actId="47"/>
        <pc:sldMkLst>
          <pc:docMk/>
          <pc:sldMk cId="1575513459" sldId="259"/>
        </pc:sldMkLst>
      </pc:sldChg>
      <pc:sldChg chg="del">
        <pc:chgData name="CAIRNS, Jill Elizabeth (CIMMYT-Zimbabwe)" userId="a5b6228f-5cdd-4f40-b78c-ba4e8c2e086b" providerId="ADAL" clId="{44492767-D7D2-48AC-A1D8-C1FADBF7B2F2}" dt="2024-09-15T15:44:28.043" v="4" actId="47"/>
        <pc:sldMkLst>
          <pc:docMk/>
          <pc:sldMk cId="3326696241" sldId="260"/>
        </pc:sldMkLst>
      </pc:sldChg>
      <pc:sldChg chg="del">
        <pc:chgData name="CAIRNS, Jill Elizabeth (CIMMYT-Zimbabwe)" userId="a5b6228f-5cdd-4f40-b78c-ba4e8c2e086b" providerId="ADAL" clId="{44492767-D7D2-48AC-A1D8-C1FADBF7B2F2}" dt="2024-09-15T15:44:29.259" v="5" actId="47"/>
        <pc:sldMkLst>
          <pc:docMk/>
          <pc:sldMk cId="3017212699" sldId="261"/>
        </pc:sldMkLst>
      </pc:sldChg>
      <pc:sldChg chg="modSp mod">
        <pc:chgData name="CAIRNS, Jill Elizabeth (CIMMYT-Zimbabwe)" userId="a5b6228f-5cdd-4f40-b78c-ba4e8c2e086b" providerId="ADAL" clId="{44492767-D7D2-48AC-A1D8-C1FADBF7B2F2}" dt="2024-09-15T15:44:34.997" v="6" actId="113"/>
        <pc:sldMkLst>
          <pc:docMk/>
          <pc:sldMk cId="1642498123" sldId="262"/>
        </pc:sldMkLst>
        <pc:spChg chg="mod">
          <ac:chgData name="CAIRNS, Jill Elizabeth (CIMMYT-Zimbabwe)" userId="a5b6228f-5cdd-4f40-b78c-ba4e8c2e086b" providerId="ADAL" clId="{44492767-D7D2-48AC-A1D8-C1FADBF7B2F2}" dt="2024-09-15T15:44:34.997" v="6" actId="113"/>
          <ac:spMkLst>
            <pc:docMk/>
            <pc:sldMk cId="1642498123" sldId="262"/>
            <ac:spMk id="6" creationId="{C41F1F8C-940D-3EE2-63FA-3A56DA42341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E8C89B-44F1-4BDD-A41F-4CABC8A7F0CC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E70244-10EE-42B4-BF9F-93057A048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649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503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39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586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5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214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902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705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61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05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100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502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02FF65-9D14-4AF7-9033-A853E5B2586D}" type="datetimeFigureOut">
              <a:rPr lang="en-US" smtClean="0"/>
              <a:t>9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B186A2-F5C7-4C80-B458-513129635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49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5415C36-0097-5BBC-0781-93F62C565B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44383"/>
            <a:ext cx="9144000" cy="4064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41F1F8C-940D-3EE2-63FA-3A56DA423413}"/>
              </a:ext>
            </a:extLst>
          </p:cNvPr>
          <p:cNvSpPr txBox="1"/>
          <p:nvPr/>
        </p:nvSpPr>
        <p:spPr>
          <a:xfrm>
            <a:off x="33470" y="921163"/>
            <a:ext cx="899165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Aptos" panose="020B0004020202020204" pitchFamily="34" charset="0"/>
              </a:rPr>
              <a:t>Supplementary Fig. 1. Visual check of various model assumptions for the joint model (normality of residuals, normality of random effects, linear relationship, homogeneity of variance). </a:t>
            </a:r>
          </a:p>
        </p:txBody>
      </p:sp>
    </p:spTree>
    <p:extLst>
      <p:ext uri="{BB962C8B-B14F-4D97-AF65-F5344CB8AC3E}">
        <p14:creationId xmlns:p14="http://schemas.microsoft.com/office/powerpoint/2010/main" val="1642498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</TotalTime>
  <Words>3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IRNS, Jill Elizabeth (CIMMYT-Zimbabwe)</dc:creator>
  <cp:lastModifiedBy>CAIRNS, Jill Elizabeth (CIMMYT-Zimbabwe)</cp:lastModifiedBy>
  <cp:revision>8</cp:revision>
  <dcterms:created xsi:type="dcterms:W3CDTF">2024-07-10T13:08:34Z</dcterms:created>
  <dcterms:modified xsi:type="dcterms:W3CDTF">2024-09-15T15:44:35Z</dcterms:modified>
</cp:coreProperties>
</file>